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haela Pešová" initials="MP" lastIdx="3" clrIdx="0">
    <p:extLst>
      <p:ext uri="{19B8F6BF-5375-455C-9EA6-DF929625EA0E}">
        <p15:presenceInfo xmlns:p15="http://schemas.microsoft.com/office/powerpoint/2012/main" userId="Michaela Pešová" providerId="None"/>
      </p:ext>
    </p:extLst>
  </p:cmAuthor>
  <p:cmAuthor id="2" name="Jitka Malčíková" initials="JM" lastIdx="2" clrIdx="1">
    <p:extLst>
      <p:ext uri="{19B8F6BF-5375-455C-9EA6-DF929625EA0E}">
        <p15:presenceInfo xmlns:p15="http://schemas.microsoft.com/office/powerpoint/2012/main" userId="Jitka Malčíková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0" autoAdjust="0"/>
    <p:restoredTop sz="94660"/>
  </p:normalViewPr>
  <p:slideViewPr>
    <p:cSldViewPr snapToGrid="0">
      <p:cViewPr varScale="1">
        <p:scale>
          <a:sx n="67" d="100"/>
          <a:sy n="67" d="100"/>
        </p:scale>
        <p:origin x="452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commentAuthors" Target="comment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DD7925-97C7-475F-BBAE-D22E1CD24C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5B35247-AC38-405E-A65D-E02EB9F80A8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de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E53F8C-E005-4152-BE19-302489D39B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9C16C-CC98-4E96-9B76-BA1F59F730C1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6FF608-700E-4CB1-B6A1-7E208F72FE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A4BBEE-E409-4FD3-A27D-7BE3E6D06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F25A1-43C9-4F96-909E-50E35D1B928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1188015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3C9D0B-82B2-4C57-A589-4790DC71E4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08D6429-3446-4D5C-88F9-E2E9C03942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5FC708-1571-4961-8976-6DBA3E67CD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9C16C-CC98-4E96-9B76-BA1F59F730C1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B88583-1578-4422-9104-1F1CCACCA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96DF45-8D04-447B-9FE6-8B1F011AD4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F25A1-43C9-4F96-909E-50E35D1B928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2943628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7389CFA-271F-4709-A5DE-876FAB9CE10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E171570-EAB8-47F8-BD85-B21784E488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93478A-88D6-4A10-9099-5322281900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9C16C-CC98-4E96-9B76-BA1F59F730C1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668054-9C1A-4DB3-BD3C-9274C7BAB6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C75B20-12BB-4342-BB3E-95DDD48918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F25A1-43C9-4F96-909E-50E35D1B928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467379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6D6389-E3C9-4615-995D-3646D1DA01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8F438B-C1F2-4196-AC2F-A1F9404C7A9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D5FD58-D328-402A-AD17-E9D341ED61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9C16C-CC98-4E96-9B76-BA1F59F730C1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E9F40A-DE90-4745-9621-B8E1D6E5E8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D59D55-35AE-4DF0-8025-FC559AE369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F25A1-43C9-4F96-909E-50E35D1B928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054232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11FEA1-E806-416E-982B-C98E030FBD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CA8407-CD08-4E06-B093-4FA109C711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7B72FA-283D-4F19-AB8C-0B1E425657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9C16C-CC98-4E96-9B76-BA1F59F730C1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E03EFB-46B4-48D7-B9C6-66B5FA6E14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5BA702-80ED-4C92-95BF-AC58F07B7A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F25A1-43C9-4F96-909E-50E35D1B928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745002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BFF0CB-26F8-46BA-A199-455EA3CCFC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13BBE0-D379-4230-8B92-9EC8CD5F76F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E9DA4F-B06C-4AEC-950D-E0ACD9138D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AE90C5-E019-4284-87A5-0063D7BCD8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9C16C-CC98-4E96-9B76-BA1F59F730C1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99E8AE-8666-4A5A-8CDA-63894CC163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7292D4-CC12-4B5E-A949-E4DC52BDFC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F25A1-43C9-4F96-909E-50E35D1B928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552861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7D193C-91CD-4031-BA30-2A229BABF5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6026C5-B20C-4F9D-835A-37911BECA9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758B710-375A-489B-AAFD-05CBFCD792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782E0D2-9DEB-4F0C-8FA1-B51F93EB028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C5B16B7-F40B-47B4-AE30-3B5B0CF459E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AEF56E0-017A-485C-8FA6-9378A15A89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9C16C-CC98-4E96-9B76-BA1F59F730C1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D7A0441-4C08-4AEC-BF4F-686422FE17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5B3078D-5B9B-4B64-8AEF-346BDE996F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F25A1-43C9-4F96-909E-50E35D1B928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3162386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E25F46-91CD-4C7B-AC31-CF29757B1A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952130C-8233-4D81-83D9-656FFA5E61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9C16C-CC98-4E96-9B76-BA1F59F730C1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10C32F-1EB1-4961-B0B4-7054D77D9F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64FBEC4-16F9-4C4B-A4FE-17F9D10F72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F25A1-43C9-4F96-909E-50E35D1B928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4861054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D3FCB62-B2AB-46F3-B246-A199C2CADB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9C16C-CC98-4E96-9B76-BA1F59F730C1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D0CEB10-6E08-47DD-B826-9898D3A4D8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5FBE4D0-6CF0-48CE-8645-277B23DA9D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F25A1-43C9-4F96-909E-50E35D1B928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131003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5AE928-A13F-4EA0-9DCB-AF7409268E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104969-C558-4D2C-813F-3EDFFFD6E8B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6E0729-EC0C-4CED-BCD7-77F7B92475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27FE8B-51BC-4F69-AD29-116B5680E5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9C16C-CC98-4E96-9B76-BA1F59F730C1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1B043C-E33D-440E-8CF8-ED51B33BE8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55E62D-C2BB-4DF2-B1D7-5A250779F0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F25A1-43C9-4F96-909E-50E35D1B928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3103023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E15374-F141-4A4C-87E1-B435295246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DE6482C-1A40-40A0-B36E-52A5A0C49F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9C4E1A0-EE00-4245-892F-169125B4EB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95420D-7BBE-48DD-B842-2600E980EE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9C16C-CC98-4E96-9B76-BA1F59F730C1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B742D0-DDB8-4680-83EC-D86305E315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4E2A94-95DE-48E5-9A0C-FFF0E8C4AF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F25A1-43C9-4F96-909E-50E35D1B928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5787820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BE927D3-055D-4889-9E24-F5B85EB347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625F2C-CD27-4664-8D85-988220582D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362625-F8AC-4F6D-90DD-23C4AED541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09C16C-CC98-4E96-9B76-BA1F59F730C1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F82EF1-9358-42AA-91EA-2F6FD7DC7F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A44946-F0ED-40B7-A9C6-12760AE917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F25A1-43C9-4F96-909E-50E35D1B928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0220126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Chart&#10;&#10;Description automatically generated">
            <a:extLst>
              <a:ext uri="{FF2B5EF4-FFF2-40B4-BE49-F238E27FC236}">
                <a16:creationId xmlns:a16="http://schemas.microsoft.com/office/drawing/2014/main" id="{BA73E906-C241-40CA-9D90-0345AEC6895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9158" y="223478"/>
            <a:ext cx="3782568" cy="491032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D52BD17-7663-45AE-8164-5456D6F85C3A}"/>
              </a:ext>
            </a:extLst>
          </p:cNvPr>
          <p:cNvSpPr txBox="1"/>
          <p:nvPr/>
        </p:nvSpPr>
        <p:spPr>
          <a:xfrm>
            <a:off x="78600" y="60760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2223933-4286-4CF5-9D37-FD75D7426368}"/>
              </a:ext>
            </a:extLst>
          </p:cNvPr>
          <p:cNvSpPr txBox="1"/>
          <p:nvPr/>
        </p:nvSpPr>
        <p:spPr>
          <a:xfrm>
            <a:off x="5444621" y="60760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B0BE2BD-F394-4E03-81BD-B1804609C9C9}"/>
              </a:ext>
            </a:extLst>
          </p:cNvPr>
          <p:cNvSpPr txBox="1"/>
          <p:nvPr/>
        </p:nvSpPr>
        <p:spPr>
          <a:xfrm>
            <a:off x="47515" y="5618859"/>
            <a:ext cx="1209697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cs-CZ" sz="1200" b="1" dirty="0"/>
              <a:t>Supplementary </a:t>
            </a:r>
            <a:r>
              <a:rPr lang="en-GB" sz="1200" b="1" dirty="0"/>
              <a:t>F</a:t>
            </a:r>
            <a:r>
              <a:rPr lang="cs-CZ" sz="1200" b="1" dirty="0"/>
              <a:t>igure S</a:t>
            </a:r>
            <a:r>
              <a:rPr lang="en-GB" sz="1200" b="1" dirty="0"/>
              <a:t>6</a:t>
            </a:r>
            <a:r>
              <a:rPr lang="cs-CZ" sz="1200" b="1" dirty="0"/>
              <a:t>.</a:t>
            </a:r>
            <a:r>
              <a:rPr lang="en-GB" sz="1200" b="1" dirty="0"/>
              <a:t> </a:t>
            </a:r>
            <a:r>
              <a:rPr lang="en-GB" sz="1200" dirty="0"/>
              <a:t>Patients’ clinical outcome in relation to phospho-profiles. </a:t>
            </a:r>
            <a:r>
              <a:rPr lang="en-US" sz="1200" b="1" dirty="0">
                <a:ea typeface="Calibri" panose="020F0502020204030204" pitchFamily="34" charset="0"/>
              </a:rPr>
              <a:t>A.</a:t>
            </a:r>
            <a:r>
              <a:rPr lang="en-US" sz="1200" dirty="0">
                <a:ea typeface="Calibri" panose="020F0502020204030204" pitchFamily="34" charset="0"/>
              </a:rPr>
              <a:t> </a:t>
            </a:r>
            <a:r>
              <a:rPr lang="en-US" sz="1200" dirty="0"/>
              <a:t>A sub-cohort of patients uniformly treated by the chemoimmunotherapy regimen </a:t>
            </a:r>
            <a:r>
              <a:rPr lang="en-US" sz="1200" dirty="0" err="1"/>
              <a:t>fludarabine+chlorambuci+rituximab</a:t>
            </a:r>
            <a:r>
              <a:rPr lang="en-US" sz="1200" dirty="0"/>
              <a:t> (FCR; N=20) was analyzed for the time to second treatment (TTST).</a:t>
            </a:r>
            <a:r>
              <a:rPr lang="en-US" sz="1200" dirty="0">
                <a:ea typeface="Calibri" panose="020F0502020204030204" pitchFamily="34" charset="0"/>
              </a:rPr>
              <a:t> </a:t>
            </a:r>
            <a:r>
              <a:rPr lang="en-US" sz="1200" b="1" dirty="0">
                <a:ea typeface="Calibri" panose="020F0502020204030204" pitchFamily="34" charset="0"/>
              </a:rPr>
              <a:t>B.</a:t>
            </a:r>
            <a:r>
              <a:rPr lang="en-US" sz="1200" dirty="0">
                <a:ea typeface="Calibri" panose="020F0502020204030204" pitchFamily="34" charset="0"/>
              </a:rPr>
              <a:t> For overall survival (OS), patients were stratified as to whether they received targeted inhibitor treatment at any time during the course of the disease. No difference between profile I and profile II was observed.</a:t>
            </a:r>
            <a:endParaRPr lang="cs-CZ" sz="1200" dirty="0">
              <a:ea typeface="Calibri" panose="020F0502020204030204" pitchFamily="34" charset="0"/>
            </a:endParaRPr>
          </a:p>
        </p:txBody>
      </p:sp>
      <p:pic>
        <p:nvPicPr>
          <p:cNvPr id="3" name="Obrázek 2">
            <a:extLst>
              <a:ext uri="{FF2B5EF4-FFF2-40B4-BE49-F238E27FC236}">
                <a16:creationId xmlns:a16="http://schemas.microsoft.com/office/drawing/2014/main" id="{4B1992C5-19A3-4ECD-B9EA-5591B3C41C5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7484" y="312929"/>
            <a:ext cx="3779520" cy="3398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76018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ABAB828607365940A4C2A1E900751875" ma:contentTypeVersion="12" ma:contentTypeDescription="Vytvoří nový dokument" ma:contentTypeScope="" ma:versionID="965b6f99110e7d39107957bfebd528c8">
  <xsd:schema xmlns:xsd="http://www.w3.org/2001/XMLSchema" xmlns:xs="http://www.w3.org/2001/XMLSchema" xmlns:p="http://schemas.microsoft.com/office/2006/metadata/properties" xmlns:ns3="4222c294-1796-45f7-b0d0-d6394c695383" xmlns:ns4="3344fa38-8c71-493c-9cd0-d30a8dd7f9df" targetNamespace="http://schemas.microsoft.com/office/2006/metadata/properties" ma:root="true" ma:fieldsID="4939462029e524c702d6048e0c66ff60" ns3:_="" ns4:_="">
    <xsd:import namespace="4222c294-1796-45f7-b0d0-d6394c695383"/>
    <xsd:import namespace="3344fa38-8c71-493c-9cd0-d30a8dd7f9df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DateTaken" minOccurs="0"/>
                <xsd:element ref="ns4:MediaServiceAutoTags" minOccurs="0"/>
                <xsd:element ref="ns4:MediaServiceGenerationTime" minOccurs="0"/>
                <xsd:element ref="ns4:MediaServiceEventHashCode" minOccurs="0"/>
                <xsd:element ref="ns4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222c294-1796-45f7-b0d0-d6394c695383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dílí se s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dílené s podrobnostmi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Hodnota hash upozornění na sdílení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344fa38-8c71-493c-9cd0-d30a8dd7f9d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 obsahu"/>
        <xsd:element ref="dc:title" minOccurs="0" maxOccurs="1" ma:index="4" ma:displayName="Nadpis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6D78E2B2-677A-46DD-9413-FB59251C259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222c294-1796-45f7-b0d0-d6394c695383"/>
    <ds:schemaRef ds:uri="3344fa38-8c71-493c-9cd0-d30a8dd7f9d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8CE15787-6D18-41DB-9252-7CE11D0B47F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6F5D9348-55A5-4DEE-A328-80C92264D84E}">
  <ds:schemaRefs>
    <ds:schemaRef ds:uri="http://schemas.openxmlformats.org/package/2006/metadata/core-properties"/>
    <ds:schemaRef ds:uri="http://www.w3.org/XML/1998/namespace"/>
    <ds:schemaRef ds:uri="http://purl.org/dc/elements/1.1/"/>
    <ds:schemaRef ds:uri="http://schemas.microsoft.com/office/2006/documentManagement/types"/>
    <ds:schemaRef ds:uri="http://schemas.microsoft.com/office/infopath/2007/PartnerControls"/>
    <ds:schemaRef ds:uri="3344fa38-8c71-493c-9cd0-d30a8dd7f9df"/>
    <ds:schemaRef ds:uri="4222c294-1796-45f7-b0d0-d6394c695383"/>
    <ds:schemaRef ds:uri="http://schemas.microsoft.com/office/2006/metadata/properties"/>
    <ds:schemaRef ds:uri="http://purl.org/dc/dcmitype/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2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ronika Mancikova</dc:creator>
  <cp:lastModifiedBy>Veronika Mancikova</cp:lastModifiedBy>
  <cp:revision>6</cp:revision>
  <dcterms:created xsi:type="dcterms:W3CDTF">2022-09-14T05:44:00Z</dcterms:created>
  <dcterms:modified xsi:type="dcterms:W3CDTF">2022-09-19T12:38:1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BAB828607365940A4C2A1E900751875</vt:lpwstr>
  </property>
</Properties>
</file>